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D026A-87C7-4522-97C9-281D5BCA6B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77239-1624-4E06-8965-E4FCB8156A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0CCFA-407D-4D8A-A548-6124BA413C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CD55E-2AC4-4633-A893-54FB29AF3B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B2649E-E8FD-42F8-8651-3FF945E638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7565B2-D759-496F-BBA1-418381B60C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91257A-BE93-4779-8523-C62A633003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504DF-55C0-4AF2-AB19-76AE4E4652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2287C4-BB8B-4DB0-8876-F52C0C8E72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B6E0CA-A153-4720-A659-6D17A8EB32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912D3-1AB4-403E-90BF-E5D502E348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71C1B-7329-4B47-A429-6EC5143AAD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1B42D3-5512-4D5A-A268-48BBB9C3E01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36560" y="930240"/>
            <a:ext cx="266040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A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c0c0c0"/>
                </a:solidFill>
                <a:latin typeface="Arial"/>
              </a:rPr>
              <a:t>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T</a:t>
            </a:r>
            <a:r>
              <a:rPr b="1" lang="de-DE" sz="1200" spc="-1" strike="noStrike">
                <a:solidFill>
                  <a:srgbClr val="c0c0c0"/>
                </a:solidFill>
                <a:latin typeface="Arial"/>
              </a:rPr>
              <a:t>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</a:t>
            </a:r>
            <a:r>
              <a:rPr b="1" lang="de-DE" sz="1200" spc="-1" strike="noStrike">
                <a:solidFill>
                  <a:srgbClr val="c0c0c0"/>
                </a:solidFill>
                <a:latin typeface="Arial"/>
              </a:rPr>
              <a:t>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X_tropicali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42320" y="2717640"/>
            <a:ext cx="26679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A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</a:t>
            </a:r>
            <a:r>
              <a:rPr b="1" lang="de-DE" sz="1200" spc="-1" strike="noStrike">
                <a:solidFill>
                  <a:srgbClr val="c0c0c0"/>
                </a:solidFill>
                <a:latin typeface="Arial"/>
              </a:rPr>
              <a:t>C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X_tropicali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c0c0c0"/>
                </a:solidFill>
                <a:latin typeface="Arial"/>
              </a:rPr>
              <a:t>G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1" lang="de-DE" sz="1200" spc="-1" strike="noStrike">
                <a:solidFill>
                  <a:srgbClr val="c0c0c0"/>
                </a:solidFill>
                <a:latin typeface="Arial"/>
              </a:rPr>
              <a:t>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744480" y="4491000"/>
            <a:ext cx="26510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A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673520" y="922320"/>
            <a:ext cx="26514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A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1" lang="de-DE" sz="1200" spc="-1" strike="noStrike">
                <a:solidFill>
                  <a:srgbClr val="c0c0c0"/>
                </a:solidFill>
                <a:latin typeface="Arial"/>
              </a:rPr>
              <a:t>C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ATAA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Opossum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hicken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=======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08T16:18:48Z</dcterms:created>
  <dc:creator>Administrator</dc:creator>
  <dc:description/>
  <dc:language>en-US</dc:language>
  <cp:lastModifiedBy>winter</cp:lastModifiedBy>
  <dcterms:modified xsi:type="dcterms:W3CDTF">2007-07-10T08:17:58Z</dcterms:modified>
  <cp:revision>3</cp:revision>
  <dc:subject/>
  <dc:title>Folie 1</dc:title>
</cp:coreProperties>
</file>